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6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127" d="100"/>
          <a:sy n="127" d="100"/>
        </p:scale>
        <p:origin x="106" y="9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378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9539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7777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6060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6498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3362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915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4984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5737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5492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2909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525A-ED1D-482D-B480-A195AF35A81C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AD6B8-0BAC-4533-9D33-E15B74FDF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7335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jpeg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eg"/><Relationship Id="rId5" Type="http://schemas.microsoft.com/office/2007/relationships/hdphoto" Target="../media/hdphoto8.wdp"/><Relationship Id="rId10" Type="http://schemas.openxmlformats.org/officeDocument/2006/relationships/image" Target="../media/image19.jpeg"/><Relationship Id="rId4" Type="http://schemas.openxmlformats.org/officeDocument/2006/relationships/image" Target="../media/image16.jpeg"/><Relationship Id="rId9" Type="http://schemas.microsoft.com/office/2007/relationships/hdphoto" Target="../media/hdphoto10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1.jpeg"/><Relationship Id="rId7" Type="http://schemas.microsoft.com/office/2007/relationships/hdphoto" Target="../media/hdphoto11.wdp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jpeg"/><Relationship Id="rId11" Type="http://schemas.microsoft.com/office/2007/relationships/hdphoto" Target="../media/hdphoto13.wdp"/><Relationship Id="rId5" Type="http://schemas.openxmlformats.org/officeDocument/2006/relationships/image" Target="../media/image23.jpeg"/><Relationship Id="rId10" Type="http://schemas.openxmlformats.org/officeDocument/2006/relationships/image" Target="../media/image26.jpeg"/><Relationship Id="rId4" Type="http://schemas.openxmlformats.org/officeDocument/2006/relationships/image" Target="../media/image22.jpeg"/><Relationship Id="rId9" Type="http://schemas.microsoft.com/office/2007/relationships/hdphoto" Target="../media/hdphoto12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3" Type="http://schemas.openxmlformats.org/officeDocument/2006/relationships/image" Target="../media/image28.jpeg"/><Relationship Id="rId7" Type="http://schemas.openxmlformats.org/officeDocument/2006/relationships/image" Target="../media/image32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jpeg"/><Relationship Id="rId5" Type="http://schemas.openxmlformats.org/officeDocument/2006/relationships/image" Target="../media/image30.jpeg"/><Relationship Id="rId4" Type="http://schemas.openxmlformats.org/officeDocument/2006/relationships/image" Target="../media/image29.jpeg"/><Relationship Id="rId9" Type="http://schemas.microsoft.com/office/2007/relationships/hdphoto" Target="../media/hdphoto1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C:\Users\hahahamj\Desktop\ID3\12.08.12 ID3 comet.mdb\GFP-4.jpg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3776" y="3645024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6" name="Picture 2" descr="C:\Users\hahahamj\Desktop\ID3\12.08.12 ID3 comet.mdb\GFP-5.jpg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3625415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hahahamj\Desktop\ID3\12.08.12 ID3 comet.mdb\GFP-6.jpg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3625415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C:\Users\hahahamj\Desktop\ID3\12.08.12 ID3 comet.mdb\GFP-1.jpg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196752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C:\Users\hahahamj\Desktop\ID3\12.08.12 ID3 comet.mdb\GFP-2.jpg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1196752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C:\Users\hahahamj\Desktop\ID3\12.08.12 ID3 comet.mdb\GFP-3.jpg"/>
          <p:cNvPicPr>
            <a:picLocks noChangeAspect="1" noChangeArrowheads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7457" y="1196752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77108" y="404664"/>
            <a:ext cx="28536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- IR 1 </a:t>
            </a:r>
            <a:r>
              <a:rPr lang="en-US" altLang="ko-KR" sz="2400" dirty="0" err="1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ko-KR" altLang="en-US" sz="2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4225504" y="3535175"/>
            <a:ext cx="2448272" cy="248611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76056" y="6138062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7g mock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5147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3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577" y="3570054"/>
            <a:ext cx="1800001" cy="1799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4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622" y="3570054"/>
            <a:ext cx="1800001" cy="1799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5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7198" y="3570054"/>
            <a:ext cx="1800001" cy="1799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6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2487" y="3570054"/>
            <a:ext cx="1800001" cy="1799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0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6822" y="1484784"/>
            <a:ext cx="1800000" cy="180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2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5996" y="1484784"/>
            <a:ext cx="1800000" cy="180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13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9886" y="1512592"/>
            <a:ext cx="1800000" cy="180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5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1165" y="1517277"/>
            <a:ext cx="1800000" cy="180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직사각형 12"/>
          <p:cNvSpPr/>
          <p:nvPr/>
        </p:nvSpPr>
        <p:spPr>
          <a:xfrm>
            <a:off x="2938578" y="3501008"/>
            <a:ext cx="1898664" cy="194421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TextBox 13"/>
          <p:cNvSpPr txBox="1"/>
          <p:nvPr/>
        </p:nvSpPr>
        <p:spPr>
          <a:xfrm>
            <a:off x="3347864" y="5856075"/>
            <a:ext cx="1327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7i mock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77108" y="404664"/>
            <a:ext cx="28536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- IR 1 </a:t>
            </a:r>
            <a:r>
              <a:rPr lang="en-US" altLang="ko-KR" sz="2400" dirty="0" err="1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ko-KR" altLang="en-US" sz="2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69823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1" name="Picture 1" descr="C:\Users\hahahamj\Desktop\ID3\12.08.12 ID3 comet.mdb\ID3-4.jpg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4265" y="3639550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2" name="Picture 2" descr="C:\Users\hahahamj\Desktop\ID3\12.08.12 ID3 comet.mdb\ID3-5.jpg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1877" y="3639550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hahahamj\Desktop\ID3\12.08.12 ID3 comet.mdb\ID3-1.jpg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18" y="1196752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hahahamj\Desktop\ID3\12.08.12 ID3 comet.mdb\ID3-2.jpg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5886" y="1196752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hahahamj\Desktop\ID3\12.08.12 ID3 comet.mdb\ID3-3.jp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6354" y="1191278"/>
            <a:ext cx="2340000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77108" y="404664"/>
            <a:ext cx="31542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WT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3- IR 1 </a:t>
            </a:r>
            <a:r>
              <a:rPr lang="en-US" altLang="ko-KR" sz="2400" dirty="0" err="1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ko-KR" altLang="en-US" sz="2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683568" y="1191278"/>
            <a:ext cx="2491850" cy="241534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1619672" y="3662161"/>
            <a:ext cx="11079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7i WT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171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1" descr="C:\Users\hahahamj\Desktop\ID3\12.08.12 ID3 comet.mdb\HLH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2388" y="4475358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C:\Users\hahahamj\Desktop\ID3\12.08.12 ID3 comet.mdb\HLH-5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2388" y="220510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hahahamj\Desktop\ID3\12.08.12 ID3 comet.mdb\HLH-6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4144" y="447227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hahahamj\Desktop\ID3\12.08.12 ID3 comet.mdb\HLH-1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5844" y="4440453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hahahamj\Desktop\ID3\12.08.12 ID3 comet.mdb\HLH-2.jpg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4116" y="220510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hahahamj\Desktop\ID3\12.08.12 ID3 comet.mdb\HLH-3.jpg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5844" y="220510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77108" y="404664"/>
            <a:ext cx="27350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H- IR 1 </a:t>
            </a:r>
            <a:r>
              <a:rPr lang="en-US" altLang="ko-KR" sz="2400" dirty="0" err="1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ko-KR" altLang="en-US" sz="2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 descr="Z:\Lee백업\ID3-project\2012ID3\12.06.12 ID3 comet-tail길이가 전체적으로 짧음\3-HLH-5.jp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4116" y="-2738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직사각형 10"/>
          <p:cNvSpPr/>
          <p:nvPr/>
        </p:nvSpPr>
        <p:spPr>
          <a:xfrm>
            <a:off x="1619672" y="4344599"/>
            <a:ext cx="2448272" cy="232476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345622" y="5877272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7i HLH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171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1" descr="C:\Users\hahahamj\Desktop\ID3\12.08.12 ID3 comet.mdb\D-HLH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0232" y="2421128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2" descr="C:\Users\hahahamj\Desktop\ID3\12.08.12 ID3 comet.mdb\D-HLH-5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0232" y="465337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hahahamj\Desktop\ID3\12.08.12 ID3 comet.mdb\D-HLH-6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1960" y="465337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hahahamj\Desktop\ID3\12.08.12 ID3 comet.mdb\D-HLH-1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4653376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hahahamj\Desktop\ID3\12.08.12 ID3 comet.mdb\D-HLH-2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1960" y="239488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hahahamj\Desktop\ID3\12.08.12 ID3 comet.mdb\D-HLH-3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2394884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59910" y="692696"/>
            <a:ext cx="30075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ko-KR" sz="24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H- IR 1 </a:t>
            </a:r>
            <a:r>
              <a:rPr lang="en-US" altLang="ko-KR" sz="2400" dirty="0" err="1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ko-KR" altLang="en-US" sz="2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6" descr="C:\Users\hahahamj\Desktop\ID3\12.08.12 ID3 comet.mdb\GFP-3.jp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1960" y="136183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직사각형 9"/>
          <p:cNvSpPr/>
          <p:nvPr/>
        </p:nvSpPr>
        <p:spPr>
          <a:xfrm>
            <a:off x="4021651" y="5779"/>
            <a:ext cx="2629449" cy="241534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865136" y="1268760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7i-</a:t>
            </a:r>
            <a:r>
              <a:rPr lang="en-US" altLang="ko-KR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</a:t>
            </a:r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ko-KR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H</a:t>
            </a:r>
            <a:endParaRPr lang="ko-KR" altLang="en-US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17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8</Words>
  <Application>Microsoft Office PowerPoint</Application>
  <PresentationFormat>화면 슬라이드 쇼(4:3)</PresentationFormat>
  <Paragraphs>10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hahamj</dc:creator>
  <cp:lastModifiedBy>chosun</cp:lastModifiedBy>
  <cp:revision>8</cp:revision>
  <dcterms:created xsi:type="dcterms:W3CDTF">2012-08-20T06:28:55Z</dcterms:created>
  <dcterms:modified xsi:type="dcterms:W3CDTF">2018-05-02T13:40:44Z</dcterms:modified>
</cp:coreProperties>
</file>